
<file path=[Content_Types].xml><?xml version="1.0" encoding="utf-8"?>
<Types xmlns="http://schemas.openxmlformats.org/package/2006/content-types"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0" r:id="rId3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224" y="4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 om de ondertitelstijl van het model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B69C-7938-41AD-9EEE-9CA2A085FD3A}" type="datetimeFigureOut">
              <a:rPr lang="nl-NL" smtClean="0"/>
              <a:t>05-04-2023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30300-F73F-4E4A-BEEA-2CD4A073779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2210872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B69C-7938-41AD-9EEE-9CA2A085FD3A}" type="datetimeFigureOut">
              <a:rPr lang="nl-NL" smtClean="0"/>
              <a:t>05-04-2023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30300-F73F-4E4A-BEEA-2CD4A073779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7513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B69C-7938-41AD-9EEE-9CA2A085FD3A}" type="datetimeFigureOut">
              <a:rPr lang="nl-NL" smtClean="0"/>
              <a:t>05-04-2023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30300-F73F-4E4A-BEEA-2CD4A073779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18051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B69C-7938-41AD-9EEE-9CA2A085FD3A}" type="datetimeFigureOut">
              <a:rPr lang="nl-NL" smtClean="0"/>
              <a:t>05-04-2023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30300-F73F-4E4A-BEEA-2CD4A073779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750459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B69C-7938-41AD-9EEE-9CA2A085FD3A}" type="datetimeFigureOut">
              <a:rPr lang="nl-NL" smtClean="0"/>
              <a:t>05-04-2023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30300-F73F-4E4A-BEEA-2CD4A073779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12103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B69C-7938-41AD-9EEE-9CA2A085FD3A}" type="datetimeFigureOut">
              <a:rPr lang="nl-NL" smtClean="0"/>
              <a:t>05-04-2023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30300-F73F-4E4A-BEEA-2CD4A073779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3863707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B69C-7938-41AD-9EEE-9CA2A085FD3A}" type="datetimeFigureOut">
              <a:rPr lang="nl-NL" smtClean="0"/>
              <a:t>05-04-2023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30300-F73F-4E4A-BEEA-2CD4A073779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75820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B69C-7938-41AD-9EEE-9CA2A085FD3A}" type="datetimeFigureOut">
              <a:rPr lang="nl-NL" smtClean="0"/>
              <a:t>05-04-2023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30300-F73F-4E4A-BEEA-2CD4A073779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0258306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B69C-7938-41AD-9EEE-9CA2A085FD3A}" type="datetimeFigureOut">
              <a:rPr lang="nl-NL" smtClean="0"/>
              <a:t>05-04-2023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30300-F73F-4E4A-BEEA-2CD4A073779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59203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B69C-7938-41AD-9EEE-9CA2A085FD3A}" type="datetimeFigureOut">
              <a:rPr lang="nl-NL" smtClean="0"/>
              <a:t>05-04-2023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30300-F73F-4E4A-BEEA-2CD4A073779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783489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B69C-7938-41AD-9EEE-9CA2A085FD3A}" type="datetimeFigureOut">
              <a:rPr lang="nl-NL" smtClean="0"/>
              <a:t>05-04-2023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30300-F73F-4E4A-BEEA-2CD4A073779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88146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42B69C-7938-41AD-9EEE-9CA2A085FD3A}" type="datetimeFigureOut">
              <a:rPr lang="nl-NL" smtClean="0"/>
              <a:t>05-04-2023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130300-F73F-4E4A-BEEA-2CD4A073779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254747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2.xml"/><Relationship Id="rId4" Type="http://schemas.openxmlformats.org/officeDocument/2006/relationships/video" Target="../media/media2.mp4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media" Target="../media/media4.mp4"/><Relationship Id="rId7" Type="http://schemas.openxmlformats.org/officeDocument/2006/relationships/image" Target="../media/image4.png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6" Type="http://schemas.openxmlformats.org/officeDocument/2006/relationships/image" Target="../media/image3.png"/><Relationship Id="rId5" Type="http://schemas.openxmlformats.org/officeDocument/2006/relationships/slideLayout" Target="../slideLayouts/slideLayout2.xml"/><Relationship Id="rId4" Type="http://schemas.openxmlformats.org/officeDocument/2006/relationships/video" Target="../media/media4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AL425 submandibularis li 9124047">
            <a:hlinkClick r:id="" action="ppaction://media"/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6696734" y="442942"/>
            <a:ext cx="4782422" cy="5726789"/>
          </a:xfrm>
        </p:spPr>
      </p:pic>
      <p:pic>
        <p:nvPicPr>
          <p:cNvPr id="5" name="AL425 parotis li  9124047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712844" y="442942"/>
            <a:ext cx="4782423" cy="5727770"/>
          </a:xfrm>
          <a:prstGeom prst="rect">
            <a:avLst/>
          </a:prstGeom>
        </p:spPr>
      </p:pic>
      <p:sp>
        <p:nvSpPr>
          <p:cNvPr id="3" name="Tekstvak 5">
            <a:extLst>
              <a:ext uri="{FF2B5EF4-FFF2-40B4-BE49-F238E27FC236}">
                <a16:creationId xmlns:a16="http://schemas.microsoft.com/office/drawing/2014/main" id="{31F0642D-57A6-6D28-64FB-531C4044013A}"/>
              </a:ext>
            </a:extLst>
          </p:cNvPr>
          <p:cNvSpPr txBox="1"/>
          <p:nvPr/>
        </p:nvSpPr>
        <p:spPr>
          <a:xfrm>
            <a:off x="820542" y="885855"/>
            <a:ext cx="508000" cy="38798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ln>
                  <a:noFill/>
                </a:ln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NL" sz="14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kstvak 4">
            <a:extLst>
              <a:ext uri="{FF2B5EF4-FFF2-40B4-BE49-F238E27FC236}">
                <a16:creationId xmlns:a16="http://schemas.microsoft.com/office/drawing/2014/main" id="{2FEDAC50-4C55-B898-C857-4D88C73BE67D}"/>
              </a:ext>
            </a:extLst>
          </p:cNvPr>
          <p:cNvSpPr txBox="1"/>
          <p:nvPr/>
        </p:nvSpPr>
        <p:spPr>
          <a:xfrm>
            <a:off x="1328541" y="885855"/>
            <a:ext cx="1972219" cy="387984"/>
          </a:xfrm>
          <a:prstGeom prst="rect">
            <a:avLst/>
          </a:prstGeom>
          <a:solidFill>
            <a:schemeClr val="tx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nl-NL" sz="1400" dirty="0" err="1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Left</a:t>
            </a:r>
            <a:r>
              <a:rPr lang="nl-NL" sz="1400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400" dirty="0" err="1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rotid</a:t>
            </a:r>
            <a:r>
              <a:rPr lang="nl-NL" sz="1400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400" dirty="0" err="1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land</a:t>
            </a:r>
            <a:endParaRPr lang="nl-NL" sz="14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kstvak 6">
            <a:extLst>
              <a:ext uri="{FF2B5EF4-FFF2-40B4-BE49-F238E27FC236}">
                <a16:creationId xmlns:a16="http://schemas.microsoft.com/office/drawing/2014/main" id="{7A0FEAB0-08CB-D96B-580C-D5331A317134}"/>
              </a:ext>
            </a:extLst>
          </p:cNvPr>
          <p:cNvSpPr txBox="1"/>
          <p:nvPr/>
        </p:nvSpPr>
        <p:spPr>
          <a:xfrm>
            <a:off x="6850487" y="803622"/>
            <a:ext cx="360680" cy="38798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NL" sz="14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kstvak 8">
            <a:extLst>
              <a:ext uri="{FF2B5EF4-FFF2-40B4-BE49-F238E27FC236}">
                <a16:creationId xmlns:a16="http://schemas.microsoft.com/office/drawing/2014/main" id="{2454282B-E66E-9A79-CBF8-BF1A50420DF2}"/>
              </a:ext>
            </a:extLst>
          </p:cNvPr>
          <p:cNvSpPr txBox="1"/>
          <p:nvPr/>
        </p:nvSpPr>
        <p:spPr>
          <a:xfrm>
            <a:off x="7211167" y="803621"/>
            <a:ext cx="2780326" cy="300349"/>
          </a:xfrm>
          <a:prstGeom prst="rect">
            <a:avLst/>
          </a:prstGeom>
          <a:solidFill>
            <a:schemeClr val="tx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nl-NL" sz="1400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Right </a:t>
            </a:r>
            <a:r>
              <a:rPr lang="nl-NL" sz="1400" dirty="0" err="1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bmandibular</a:t>
            </a:r>
            <a:r>
              <a:rPr lang="nl-NL" sz="1400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400" dirty="0" err="1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land</a:t>
            </a:r>
            <a:endParaRPr lang="nl-NL" sz="14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nl-NL" sz="1400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nl-NL" sz="14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851246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AL425 submandibularis re 9124047">
            <a:hlinkClick r:id="" action="ppaction://media"/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6468916" y="735979"/>
            <a:ext cx="4826618" cy="5779713"/>
          </a:xfrm>
        </p:spPr>
      </p:pic>
      <p:pic>
        <p:nvPicPr>
          <p:cNvPr id="5" name="AL425 parotis re  9124047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784266" y="734991"/>
            <a:ext cx="4826618" cy="5780701"/>
          </a:xfrm>
          <a:prstGeom prst="rect">
            <a:avLst/>
          </a:prstGeom>
        </p:spPr>
      </p:pic>
      <p:sp>
        <p:nvSpPr>
          <p:cNvPr id="7" name="Tekstvak 10">
            <a:extLst>
              <a:ext uri="{FF2B5EF4-FFF2-40B4-BE49-F238E27FC236}">
                <a16:creationId xmlns:a16="http://schemas.microsoft.com/office/drawing/2014/main" id="{4C845DA1-C0AF-A2C5-2C98-04AA86635180}"/>
              </a:ext>
            </a:extLst>
          </p:cNvPr>
          <p:cNvSpPr txBox="1"/>
          <p:nvPr/>
        </p:nvSpPr>
        <p:spPr>
          <a:xfrm>
            <a:off x="1441765" y="1014497"/>
            <a:ext cx="1836694" cy="279043"/>
          </a:xfrm>
          <a:prstGeom prst="rect">
            <a:avLst/>
          </a:prstGeom>
          <a:solidFill>
            <a:schemeClr val="tx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nl-NL" sz="1400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Right </a:t>
            </a:r>
            <a:r>
              <a:rPr lang="nl-NL" sz="1400" dirty="0" err="1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rotid</a:t>
            </a:r>
            <a:r>
              <a:rPr lang="nl-NL" sz="1400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400" dirty="0" err="1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land</a:t>
            </a:r>
            <a:endParaRPr lang="nl-NL" sz="14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kstvak 11">
            <a:extLst>
              <a:ext uri="{FF2B5EF4-FFF2-40B4-BE49-F238E27FC236}">
                <a16:creationId xmlns:a16="http://schemas.microsoft.com/office/drawing/2014/main" id="{5C5CAA8E-99F7-DC5C-533E-3770BBE3613F}"/>
              </a:ext>
            </a:extLst>
          </p:cNvPr>
          <p:cNvSpPr txBox="1"/>
          <p:nvPr/>
        </p:nvSpPr>
        <p:spPr>
          <a:xfrm>
            <a:off x="933765" y="1014498"/>
            <a:ext cx="508000" cy="38798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ln>
                  <a:noFill/>
                </a:ln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nl-NL" sz="14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kstvak 9">
            <a:extLst>
              <a:ext uri="{FF2B5EF4-FFF2-40B4-BE49-F238E27FC236}">
                <a16:creationId xmlns:a16="http://schemas.microsoft.com/office/drawing/2014/main" id="{3913C018-5076-6171-6A8E-629CF8510259}"/>
              </a:ext>
            </a:extLst>
          </p:cNvPr>
          <p:cNvSpPr txBox="1"/>
          <p:nvPr/>
        </p:nvSpPr>
        <p:spPr>
          <a:xfrm>
            <a:off x="6980918" y="1003082"/>
            <a:ext cx="2910214" cy="290458"/>
          </a:xfrm>
          <a:prstGeom prst="rect">
            <a:avLst/>
          </a:prstGeom>
          <a:solidFill>
            <a:schemeClr val="tx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nl-NL" sz="1400" dirty="0" err="1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Left</a:t>
            </a:r>
            <a:r>
              <a:rPr lang="nl-NL" sz="1400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400" dirty="0" err="1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bmandibular</a:t>
            </a:r>
            <a:r>
              <a:rPr lang="nl-NL" sz="1400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400" dirty="0" err="1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land</a:t>
            </a:r>
            <a:r>
              <a:rPr lang="nl-NL" sz="1400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nl-NL" sz="14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nl-NL" sz="1400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nl-NL" sz="14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kstvak 13">
            <a:extLst>
              <a:ext uri="{FF2B5EF4-FFF2-40B4-BE49-F238E27FC236}">
                <a16:creationId xmlns:a16="http://schemas.microsoft.com/office/drawing/2014/main" id="{3F8616FD-F192-D3A7-931B-AD546A46687C}"/>
              </a:ext>
            </a:extLst>
          </p:cNvPr>
          <p:cNvSpPr txBox="1"/>
          <p:nvPr/>
        </p:nvSpPr>
        <p:spPr>
          <a:xfrm>
            <a:off x="6623766" y="1014497"/>
            <a:ext cx="508000" cy="38798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ln>
                  <a:noFill/>
                </a:ln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nl-NL" sz="14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408641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</TotalTime>
  <Words>18</Words>
  <Application>Microsoft Macintosh PowerPoint</Application>
  <PresentationFormat>Breedbeeld</PresentationFormat>
  <Paragraphs>10</Paragraphs>
  <Slides>2</Slides>
  <Notes>0</Notes>
  <HiddenSlides>0</HiddenSlides>
  <MMClips>4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Kantoorthema</vt:lpstr>
      <vt:lpstr>PowerPoint-presentatie</vt:lpstr>
      <vt:lpstr>PowerPoint-presentatie</vt:lpstr>
    </vt:vector>
  </TitlesOfParts>
  <Company>VU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L 425</dc:title>
  <dc:creator>Bot, J.C.J. (Joseph)</dc:creator>
  <cp:lastModifiedBy>Derk Jan Jager</cp:lastModifiedBy>
  <cp:revision>9</cp:revision>
  <dcterms:created xsi:type="dcterms:W3CDTF">2021-02-18T09:15:51Z</dcterms:created>
  <dcterms:modified xsi:type="dcterms:W3CDTF">2023-04-05T17:20:14Z</dcterms:modified>
</cp:coreProperties>
</file>